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830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E28C436-9DC6-ACE1-0DEE-8F48403715CA}" name="Islam, Rafiqul (NIH/NCI) [E]" initials="IR([" userId="S::islams2@nih.gov::f5e29a92-aa12-430f-8b10-24b4249a5435" providerId="AD"/>
  <p188:author id="{130490E7-C091-57DA-DA20-B935654BF42E}" name="Tak Maeda" initials="TM" userId="S::tmaeda@lyell.com::e1039f30-9f51-4f9a-8ef7-fa1005af31c3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eda, Takuya (NIH/NCI) [F]" initials="MT([" lastIdx="30" clrIdx="0">
    <p:extLst>
      <p:ext uri="{19B8F6BF-5375-455C-9EA6-DF929625EA0E}">
        <p15:presenceInfo xmlns:p15="http://schemas.microsoft.com/office/powerpoint/2012/main" userId="S::maedat2@nih.gov::cb579246-00ef-4bc6-9ab3-82831aa6f9fd" providerId="AD"/>
      </p:ext>
    </p:extLst>
  </p:cmAuthor>
  <p:cmAuthor id="2" name="Islam, Rafiqul (NIH/NCI) [F]" initials="IR([" lastIdx="27" clrIdx="1">
    <p:extLst>
      <p:ext uri="{19B8F6BF-5375-455C-9EA6-DF929625EA0E}">
        <p15:presenceInfo xmlns:p15="http://schemas.microsoft.com/office/powerpoint/2012/main" userId="S::islams2@nih.gov::f5e29a92-aa12-430f-8b10-24b4249a5435" providerId="AD"/>
      </p:ext>
    </p:extLst>
  </p:cmAuthor>
  <p:cmAuthor id="3" name="Tak Maeda" initials="TM" lastIdx="5" clrIdx="2">
    <p:extLst>
      <p:ext uri="{19B8F6BF-5375-455C-9EA6-DF929625EA0E}">
        <p15:presenceInfo xmlns:p15="http://schemas.microsoft.com/office/powerpoint/2012/main" userId="S::tmaeda@lyell.com::e1039f30-9f51-4f9a-8ef7-fa1005af31c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99"/>
    <a:srgbClr val="10AC39"/>
    <a:srgbClr val="FF0066"/>
    <a:srgbClr val="0000CC"/>
    <a:srgbClr val="00FF99"/>
    <a:srgbClr val="003366"/>
    <a:srgbClr val="12C441"/>
    <a:srgbClr val="0F9D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61" autoAdjust="0"/>
    <p:restoredTop sz="96374" autoAdjust="0"/>
  </p:normalViewPr>
  <p:slideViewPr>
    <p:cSldViewPr>
      <p:cViewPr varScale="1">
        <p:scale>
          <a:sx n="94" d="100"/>
          <a:sy n="94" d="100"/>
        </p:scale>
        <p:origin x="3082" y="8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8/10/relationships/authors" Target="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F238DEBA-3D7B-430D-B307-636BB38BEBD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0AE5C62-6D89-413F-9810-CCAD3B9CBC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90769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87F1AAE2-27E9-49BE-B73F-CF03F2C3197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8500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58" tIns="46579" rIns="93158" bIns="465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1"/>
            <a:ext cx="5608320" cy="4183380"/>
          </a:xfrm>
          <a:prstGeom prst="rect">
            <a:avLst/>
          </a:prstGeom>
        </p:spPr>
        <p:txBody>
          <a:bodyPr vert="horz" lIns="93158" tIns="46579" rIns="93158" bIns="4657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3C8753E-5E29-4F5A-8447-AC49EA0A53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219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10C5-8144-458C-99FB-0D0EBF84198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6153-D410-4AEE-9CDC-DE83F17EFE80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8BC5-70FA-4424-84DD-5ECF8F0190A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F9D97-7AB9-4D0C-A30C-C72FF24D496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B97B0-2ED9-4B04-B7BA-A396D3B218D8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C45D-D7A0-4C45-BCD7-51B9D1EC4670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3569E7-30ED-4111-9DE5-232990FD1521}" type="datetime1">
              <a:rPr lang="en-US" smtClean="0"/>
              <a:t>4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1BD2B-C896-4CE5-9072-7ABE3A3029A9}" type="datetime1">
              <a:rPr lang="en-US" smtClean="0"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17C8E-737E-4198-B857-00185F1C25DA}" type="datetime1">
              <a:rPr lang="en-US" smtClean="0"/>
              <a:t>4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CFBFE-A034-4BE5-9F46-66935E132023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65F5-C15D-472B-A2E8-FA919C644EA5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E046D-0188-40C4-97EB-0FE798003F3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4CAE842-D781-4D42-BD3F-D6F4CC2167BE}"/>
              </a:ext>
            </a:extLst>
          </p:cNvPr>
          <p:cNvSpPr txBox="1"/>
          <p:nvPr/>
        </p:nvSpPr>
        <p:spPr>
          <a:xfrm>
            <a:off x="5518512" y="197358"/>
            <a:ext cx="1097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-S1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53C327C-E21E-4B70-A439-D07462C5A2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214883"/>
              </p:ext>
            </p:extLst>
          </p:nvPr>
        </p:nvGraphicFramePr>
        <p:xfrm>
          <a:off x="304800" y="539604"/>
          <a:ext cx="6324599" cy="4600086"/>
        </p:xfrm>
        <a:graphic>
          <a:graphicData uri="http://schemas.openxmlformats.org/drawingml/2006/table">
            <a:tbl>
              <a:tblPr/>
              <a:tblGrid>
                <a:gridCol w="381000">
                  <a:extLst>
                    <a:ext uri="{9D8B030D-6E8A-4147-A177-3AD203B41FA5}">
                      <a16:colId xmlns:a16="http://schemas.microsoft.com/office/drawing/2014/main" val="1769883522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634406661"/>
                    </a:ext>
                  </a:extLst>
                </a:gridCol>
                <a:gridCol w="979058">
                  <a:extLst>
                    <a:ext uri="{9D8B030D-6E8A-4147-A177-3AD203B41FA5}">
                      <a16:colId xmlns:a16="http://schemas.microsoft.com/office/drawing/2014/main" val="393777786"/>
                    </a:ext>
                  </a:extLst>
                </a:gridCol>
                <a:gridCol w="702252">
                  <a:extLst>
                    <a:ext uri="{9D8B030D-6E8A-4147-A177-3AD203B41FA5}">
                      <a16:colId xmlns:a16="http://schemas.microsoft.com/office/drawing/2014/main" val="4014063655"/>
                    </a:ext>
                  </a:extLst>
                </a:gridCol>
                <a:gridCol w="390140">
                  <a:extLst>
                    <a:ext uri="{9D8B030D-6E8A-4147-A177-3AD203B41FA5}">
                      <a16:colId xmlns:a16="http://schemas.microsoft.com/office/drawing/2014/main" val="3336618386"/>
                    </a:ext>
                  </a:extLst>
                </a:gridCol>
                <a:gridCol w="702252">
                  <a:extLst>
                    <a:ext uri="{9D8B030D-6E8A-4147-A177-3AD203B41FA5}">
                      <a16:colId xmlns:a16="http://schemas.microsoft.com/office/drawing/2014/main" val="1366249623"/>
                    </a:ext>
                  </a:extLst>
                </a:gridCol>
                <a:gridCol w="858308">
                  <a:extLst>
                    <a:ext uri="{9D8B030D-6E8A-4147-A177-3AD203B41FA5}">
                      <a16:colId xmlns:a16="http://schemas.microsoft.com/office/drawing/2014/main" val="397889575"/>
                    </a:ext>
                  </a:extLst>
                </a:gridCol>
                <a:gridCol w="1092389">
                  <a:extLst>
                    <a:ext uri="{9D8B030D-6E8A-4147-A177-3AD203B41FA5}">
                      <a16:colId xmlns:a16="http://schemas.microsoft.com/office/drawing/2014/main" val="4283208281"/>
                    </a:ext>
                  </a:extLst>
                </a:gridCol>
              </a:tblGrid>
              <a:tr h="157179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DR3</a:t>
                      </a:r>
                      <a:r>
                        <a:rPr lang="el-GR" sz="105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β</a:t>
                      </a:r>
                      <a:endParaRPr lang="en-US" sz="105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</a:t>
                      </a:r>
                      <a:r>
                        <a:rPr lang="el-GR" sz="105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β</a:t>
                      </a:r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amily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requency (%)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nrichment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east number of iPSC clone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 type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497146"/>
                  </a:ext>
                </a:extLst>
              </a:tr>
              <a:tr h="15717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ulk 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P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7074559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EIGGSIY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2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0510902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SRSGAKNI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15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4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.3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86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4046789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NPRGRVYGYT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4-02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2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5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.81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 TCR 4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2833118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ATLGENI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7-0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F TCR 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2337281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LVAGYNEQF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7-0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F TCR 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4856238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VGGNPTY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9-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4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6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.54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8151194"/>
                  </a:ext>
                </a:extLst>
              </a:tr>
              <a:tr h="1649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LSYGY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1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0117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F TCR 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5000392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LSWDRVDGYT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27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9742060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QDSGLAGGQEF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4-03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1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2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34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0214889"/>
                  </a:ext>
                </a:extLst>
              </a:tr>
              <a:tr h="1937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GGARDTDT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2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3879207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LAGGG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5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.1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5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74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3794281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PGTENTGELF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18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8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.6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88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7794185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SDSGSHDNEQF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9-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2986011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SGQGEYR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5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3877061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ASTGRSGNTI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7-0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.18</a:t>
                      </a:r>
                      <a:endParaRPr lang="en-US" sz="105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43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IR TCR IV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29303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6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EWRTGSNSPLH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2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1005887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7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LRASGRQET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27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6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.2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.30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6515109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8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STGTGFNYGYT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7-0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229782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TGYNQPQH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19-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035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5786141"/>
                  </a:ext>
                </a:extLst>
              </a:tr>
              <a:tr h="172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0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YSQVNI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27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2618613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TSTPRG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1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698626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2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HIGRTY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4-02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3847182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3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SSLADTTNTGELF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07-09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917785"/>
                  </a:ext>
                </a:extLst>
              </a:tr>
              <a:tr h="160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4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TSRLGLADYNEQF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15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0235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  <a:endParaRPr kumimoji="0" 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435283"/>
                  </a:ext>
                </a:extLst>
              </a:tr>
              <a:tr h="2477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SVGVRGGSYEQY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CRBV29-01*0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.d.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F</a:t>
                      </a:r>
                    </a:p>
                  </a:txBody>
                  <a:tcPr marL="2793" marR="2793" marT="2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784618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DB90766-6D80-4DFE-ADA7-50AEA98BE588}"/>
              </a:ext>
            </a:extLst>
          </p:cNvPr>
          <p:cNvSpPr txBox="1"/>
          <p:nvPr/>
        </p:nvSpPr>
        <p:spPr>
          <a:xfrm>
            <a:off x="2451345" y="5174159"/>
            <a:ext cx="247988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n.d. = not detected</a:t>
            </a:r>
          </a:p>
          <a:p>
            <a:r>
              <a:rPr lang="en-US" sz="1100" dirty="0"/>
              <a:t>N/A= not applicable</a:t>
            </a:r>
          </a:p>
          <a:p>
            <a:r>
              <a:rPr lang="en-US" sz="1100" dirty="0"/>
              <a:t>*NF = newly found TCR (not tested)</a:t>
            </a:r>
          </a:p>
          <a:p>
            <a:r>
              <a:rPr lang="en-US" sz="1100" dirty="0"/>
              <a:t>PIR TCR= Pre-identified reactive TC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8D63436-04EF-57EA-F6B1-D88686586F72}"/>
              </a:ext>
            </a:extLst>
          </p:cNvPr>
          <p:cNvSpPr txBox="1"/>
          <p:nvPr/>
        </p:nvSpPr>
        <p:spPr>
          <a:xfrm>
            <a:off x="152399" y="6096000"/>
            <a:ext cx="6629400" cy="27276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able S1: Summary table indicates TIL-iPSCs were established from T cells of low frequency along with major tumor neoantigen specific T cells from patient 3784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 summary table of the TCR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quencing analysis of 25 different TCRs identified in 8 master tubes containing 178 TIL-iPSC clones indicating their CDR3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mino acid sequence, V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amily, frequency in bulk (before co-culture in starting material) and in sorted PD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-1BB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DP) population, enrichment (DP/Bulk), and the least number of iPSC clones established. Right column indicates the TCR types. newly found reactive TCR (TCR 3,4, and 7) and the pre-identified tumor reactive TCR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V (TCR 15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relatively high frequency (7.18 %) in starting materials. 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5743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844</TotalTime>
  <Words>524</Words>
  <Application>Microsoft Office PowerPoint</Application>
  <PresentationFormat>On-screen Show (4:3)</PresentationFormat>
  <Paragraphs>2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Pasetto, Anna (NIH/NCI) [F]</dc:creator>
  <cp:keywords/>
  <dc:description/>
  <cp:lastModifiedBy>Islam, Rafiqul (NIH/NCI) [E]</cp:lastModifiedBy>
  <cp:revision>1441</cp:revision>
  <cp:lastPrinted>2023-02-05T19:57:40Z</cp:lastPrinted>
  <dcterms:created xsi:type="dcterms:W3CDTF">2006-08-16T00:00:00Z</dcterms:created>
  <dcterms:modified xsi:type="dcterms:W3CDTF">2023-04-29T16:53:23Z</dcterms:modified>
  <cp:category/>
</cp:coreProperties>
</file>